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EF63FB-019F-4217-AA2C-30CFD578CD9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7462D1-2DDB-4DD8-8CC5-6F158FFF0F2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0C94E6-572C-414F-B8E7-EC71C810AD9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236001-A18A-4B49-A336-D3542480FDE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7C72A3-5608-40E7-BE25-C214B7E7217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8D2702-83B8-4C11-A4E8-A898F0823B4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08E03E-23F2-4427-AF63-B3A4CBB2C0C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8DFFA5-4116-4A07-BBE6-A49ECF95E9E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9EACFF-CC86-4B6C-A1AA-D46342F552C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536AAC-A9EB-4FCA-84C9-39E0190C06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834EEB-B44F-4F7D-BA72-760506E177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A71F29-E84F-4525-AEC0-3804C59EE1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C1AA0A8-31B7-46A4-BEFD-7B0119A5851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476280" y="826920"/>
            <a:ext cx="578160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800" spc="-1" strike="noStrike">
                <a:solidFill>
                  <a:srgbClr val="000000"/>
                </a:solidFill>
                <a:latin typeface="Arial"/>
              </a:rPr>
              <a:t>Supplementary files: </a:t>
            </a:r>
            <a:r>
              <a:rPr b="0" lang="ja-JP" sz="1800" spc="-1" strike="noStrike">
                <a:solidFill>
                  <a:srgbClr val="000000"/>
                </a:solidFill>
                <a:latin typeface="Arial"/>
              </a:rPr>
              <a:t>May-Giemsa staining of TaY cells: untreated cells (A) , 5 nM of bortezomib-treated cells (B)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981000" y="5148360"/>
            <a:ext cx="4896000" cy="306360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2"/>
          <a:stretch/>
        </p:blipFill>
        <p:spPr>
          <a:xfrm>
            <a:off x="981000" y="1979640"/>
            <a:ext cx="4826160" cy="290016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/>
          <p:nvPr/>
        </p:nvSpPr>
        <p:spPr>
          <a:xfrm>
            <a:off x="983160" y="5292720"/>
            <a:ext cx="3499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054440" y="2050920"/>
            <a:ext cx="3499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7-02T05:33:48Z</dcterms:created>
  <dc:creator>大屋敷 純子</dc:creator>
  <dc:description/>
  <dc:language>en-US</dc:language>
  <cp:lastModifiedBy>大屋敷 純子</cp:lastModifiedBy>
  <dcterms:modified xsi:type="dcterms:W3CDTF">2007-07-02T05:41:09Z</dcterms:modified>
  <cp:revision>1</cp:revision>
  <dc:subject/>
  <dc:title>スライド 1</dc:title>
</cp:coreProperties>
</file>